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0972800" cy="1463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608">
          <p15:clr>
            <a:srgbClr val="A4A3A4"/>
          </p15:clr>
        </p15:guide>
        <p15:guide id="2" pos="34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46"/>
  </p:normalViewPr>
  <p:slideViewPr>
    <p:cSldViewPr snapToGrid="0">
      <p:cViewPr>
        <p:scale>
          <a:sx n="50" d="100"/>
          <a:sy n="50" d="100"/>
        </p:scale>
        <p:origin x="-1584" y="1266"/>
      </p:cViewPr>
      <p:guideLst>
        <p:guide orient="horz" pos="4608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394374"/>
            <a:ext cx="9326880" cy="5093547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684348"/>
            <a:ext cx="8229600" cy="3532292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452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252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778933"/>
            <a:ext cx="2366010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778933"/>
            <a:ext cx="6960870" cy="123985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460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864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3647444"/>
            <a:ext cx="9464040" cy="6085839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9790858"/>
            <a:ext cx="9464040" cy="3200399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933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3894667"/>
            <a:ext cx="466344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3894667"/>
            <a:ext cx="466344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09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778936"/>
            <a:ext cx="9464040" cy="28278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3586481"/>
            <a:ext cx="4642008" cy="175767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5344160"/>
            <a:ext cx="4642008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3586481"/>
            <a:ext cx="4664869" cy="175767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5344160"/>
            <a:ext cx="4664869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345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500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655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75360"/>
            <a:ext cx="3539014" cy="341376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2106510"/>
            <a:ext cx="5554980" cy="10397067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389120"/>
            <a:ext cx="3539014" cy="8131388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616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75360"/>
            <a:ext cx="3539014" cy="341376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2106510"/>
            <a:ext cx="5554980" cy="10397067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389120"/>
            <a:ext cx="3539014" cy="8131388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097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778936"/>
            <a:ext cx="946404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3894667"/>
            <a:ext cx="946404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13560217"/>
            <a:ext cx="246888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414C78-D866-4F90-96FE-E2275E360C6C}" type="datetimeFigureOut">
              <a:rPr lang="en-US" smtClean="0"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13560217"/>
            <a:ext cx="370332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13560217"/>
            <a:ext cx="246888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A6A4D-79B2-44A6-9AB5-A873A8035A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45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xmlns="" id="{8B57E0AF-6863-7B4B-98A6-535A8EDA742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363" y="256340"/>
            <a:ext cx="6019800" cy="96901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738EEC03-C9C9-BC44-B510-31AE914229CC}"/>
              </a:ext>
            </a:extLst>
          </p:cNvPr>
          <p:cNvSpPr txBox="1"/>
          <p:nvPr/>
        </p:nvSpPr>
        <p:spPr>
          <a:xfrm>
            <a:off x="971432" y="10798342"/>
            <a:ext cx="9029936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xtracted Ion Chromatogram (EIC) of targeted metabolites. 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rabidopsis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edlings were grown for 12 days on [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]ATS salts at 22 °C under ~ 100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ol m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−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−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of cool white fluorescent lights for 10/14-hour photoperiod, then subjected to labeling with [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baseline="-25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]indole. Resulting labeled compounds (tryptophan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Tr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, indole-3-acetamide (IAM), indole-3-acetaldoxime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IAO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, indole-3-acetic acid (IAA), indole-3-acetonitrile (IAN), indole-3-pyruvic acid oxime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IPyAo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ndole-3-acetaldehyde oxim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IAAldo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) were extracted from plant tissue using solid phase extraction and analyzed by LC-MS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3048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3</TotalTime>
  <Words>10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mo Scientific</dc:creator>
  <cp:lastModifiedBy>Molly</cp:lastModifiedBy>
  <cp:revision>11</cp:revision>
  <dcterms:created xsi:type="dcterms:W3CDTF">2021-05-07T18:27:21Z</dcterms:created>
  <dcterms:modified xsi:type="dcterms:W3CDTF">2021-06-04T16:26:52Z</dcterms:modified>
</cp:coreProperties>
</file>